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6" r:id="rId2"/>
    <p:sldId id="257" r:id="rId3"/>
    <p:sldId id="258" r:id="rId4"/>
    <p:sldId id="259" r:id="rId5"/>
    <p:sldId id="260" r:id="rId6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0282" autoAdjust="0"/>
  </p:normalViewPr>
  <p:slideViewPr>
    <p:cSldViewPr snapToGrid="0">
      <p:cViewPr varScale="1">
        <p:scale>
          <a:sx n="69" d="100"/>
          <a:sy n="69" d="100"/>
        </p:scale>
        <p:origin x="51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F899A5-1B82-4F5A-A777-854035A6BE08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C885B9-96B2-46B6-A62C-23DE1739F0E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517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on-priority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C885B9-96B2-46B6-A62C-23DE1739F0EA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69918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Underlying medical condition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C885B9-96B2-46B6-A62C-23DE1739F0EA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285815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65 and older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C885B9-96B2-46B6-A62C-23DE1739F0EA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87559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HCW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5C885B9-96B2-46B6-A62C-23DE1739F0EA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198638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8BA72F-EBFA-4AE0-8301-F69418281A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8B1CBB7-86B7-4D57-8B6F-B8CF138858E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AD1BE0A-ECB3-4178-A6F7-ABF7D13A10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B3A5B08-26D9-4C40-8117-A60A60A7FF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40591A-2D2B-4B9D-B654-0A2B636F36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07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FC302A-EDEB-4309-B208-E3EA138F4B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4BBD8BA-417F-497A-B955-C5B16A3E43F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4DEC62-F5F6-405D-A86A-623C1ABAD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2B8E27C-4969-4A33-B3E1-7F7B94D3F3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7CCDC6-F365-498A-91FA-F3177EA51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2235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9C6540CB-D81C-453B-A103-BE69F0E05E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F8FCD17-3489-406C-982D-7A03CCDA6A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01B6A6A-77AF-4FB8-B122-A868226E0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6D5F2E8-DDAE-49FF-ABAC-42F77BECBD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300040-9FC9-47D8-B1AC-B2DB0C5A7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4907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F39C981-AF21-4C6D-9196-528066C7DC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3AE9392-006C-41CA-8040-CF222C70535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F03E76-0C20-4982-9B1E-C8D3F9A87E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CD42425-72F3-487B-8651-7D5F9F2CA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459338-317B-47E7-9A14-13AFC2163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7962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8E1CD5B-C6AC-4B68-9D82-45FA41765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4FBF96C-5BD7-4D3B-B52E-61583D38DF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E398DF5-64A9-413C-B571-AE79CA3906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FABEF68-CAA2-4B5A-B225-E72CF459E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B17696-63EF-4063-8184-E285D129DA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0877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13EB6A-7936-48EF-B739-0B5F867127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78C0093-F3CB-465C-9F56-0E39DD9CAB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E03939D-BD62-4C2D-9C20-B6DD760938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8DA507-A9F4-46D2-AD8D-1EA8B294B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29FD70D-D31D-41C0-941A-0BCF42685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9DD3DC4-EEBA-43C0-A8F9-62FF5917CB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5989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1C16727-4885-4E33-A4DA-876775CA63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6079C26-2DFE-446E-B87A-67C7741599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6682105-9D61-46FF-B1EF-133696EB8F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EC10B04-DB5E-49F5-A65D-69F8255BA09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419E176-805F-485D-89EF-34BC4BE428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A7061C9-170B-4324-B5E1-7D0BD5A796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698EB26-2042-4898-836A-9E94A8D256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777EF066-C60A-4DED-AA2E-12FA3E49E5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9192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3237213-E91A-45DF-AAD5-C1DFF5FED4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E459FA0-291C-4B22-8863-F03483638C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F8C648A2-1EBE-4527-B840-936B13A443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D572A18-2492-43DA-8D23-23D6345C2B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288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CE9226C8-90AE-46E3-ADC8-348DDDB3F6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E56C5F13-329C-4A77-A142-3BB090EAC3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05320893-BFB1-4EB4-9010-14253E4B9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170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0114C65-E20B-46A1-9436-0AB11D51BB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F960ABF-EF6C-453B-91A7-C65F86393F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9E87716-3E69-4928-804C-E0D8BB747E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D731490-2B36-4D1E-81D1-059336BC4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C98D448-20F1-44FF-ACE9-5653A01BC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3961383-0331-473F-B032-60A0B3379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787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5EE9AA-973A-41B3-8D99-3106E5F0FF3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AAC933A7-C004-41AE-A8F1-4F2A14E4DB1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41A48CC-EDA8-4458-BDFD-67B21B3706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BEEC24B-1D43-441C-9EAC-6614EC648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997685B-ACCB-4E32-97E8-55CB095F5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36095AF-D3EB-4207-9028-9970D2FD7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68391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18321CF5-4C78-406D-9488-868EC9B16A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267AEBD-089F-4112-A6F3-EA915F83DA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2E69766-A70E-40EF-96A4-D26F1E5F48C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A000B-EB38-43CB-A0E3-3008787AD5B1}" type="datetimeFigureOut">
              <a:rPr kumimoji="1" lang="ja-JP" altLang="en-US" smtClean="0"/>
              <a:t>2023/6/2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396EED-D796-407E-A1F9-64744AE2AFF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F4A6973-F592-471E-9CCC-AE5D40C8CC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C0A94-B244-42C8-B4DE-7052EE1093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73693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4E77537-863A-2834-892E-1A33EAFB816D}"/>
              </a:ext>
            </a:extLst>
          </p:cNvPr>
          <p:cNvSpPr txBox="1"/>
          <p:nvPr/>
        </p:nvSpPr>
        <p:spPr>
          <a:xfrm>
            <a:off x="2904344" y="1399987"/>
            <a:ext cx="6383311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dirty="0">
                <a:latin typeface="Cambria" panose="02040503050406030204" pitchFamily="18" charset="0"/>
                <a:ea typeface="Cambria" panose="02040503050406030204" pitchFamily="18" charset="0"/>
              </a:rPr>
              <a:t>This is a Multimedia Appendix to a full manuscript published in the J Med Internet Res. </a:t>
            </a:r>
          </a:p>
          <a:p>
            <a:pPr algn="ctr"/>
            <a:r>
              <a:rPr lang="en-US" altLang="ja-JP" sz="2400" dirty="0">
                <a:latin typeface="Cambria" panose="02040503050406030204" pitchFamily="18" charset="0"/>
                <a:ea typeface="Cambria" panose="02040503050406030204" pitchFamily="18" charset="0"/>
              </a:rPr>
              <a:t>For full copyright and citation information see http://dx.doi.org</a:t>
            </a:r>
            <a:r>
              <a:rPr lang="en-US" altLang="ja-JP" sz="2400">
                <a:latin typeface="Cambria" panose="02040503050406030204" pitchFamily="18" charset="0"/>
                <a:ea typeface="Cambria" panose="02040503050406030204" pitchFamily="18" charset="0"/>
              </a:rPr>
              <a:t>/10.2196/42143</a:t>
            </a:r>
            <a:endParaRPr lang="ja-JP" altLang="en-US" sz="2400" dirty="0">
              <a:latin typeface="Cambria" panose="020405030504060302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D2F13FC-E63D-4EEE-A261-2210BFADF757}"/>
              </a:ext>
            </a:extLst>
          </p:cNvPr>
          <p:cNvSpPr txBox="1"/>
          <p:nvPr/>
        </p:nvSpPr>
        <p:spPr>
          <a:xfrm>
            <a:off x="1868788" y="3429000"/>
            <a:ext cx="8454422" cy="18466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2400" dirty="0">
                <a:latin typeface="Cambria" panose="02040503050406030204" pitchFamily="18" charset="0"/>
                <a:ea typeface="Cambria" panose="02040503050406030204" pitchFamily="18" charset="0"/>
              </a:rPr>
              <a:t>Shift from prior COVID-19 vaccine intention in</a:t>
            </a:r>
            <a:r>
              <a:rPr lang="ja-JP" altLang="en-US" sz="2400" dirty="0">
                <a:latin typeface="Cambria" panose="02040503050406030204" pitchFamily="18" charset="0"/>
                <a:ea typeface="Cambria" panose="02040503050406030204" pitchFamily="18" charset="0"/>
              </a:rPr>
              <a:t> </a:t>
            </a:r>
            <a:r>
              <a:rPr lang="en-US" altLang="ja-JP" sz="2400" dirty="0">
                <a:latin typeface="Cambria" panose="02040503050406030204" pitchFamily="18" charset="0"/>
                <a:ea typeface="Cambria" panose="02040503050406030204" pitchFamily="18" charset="0"/>
              </a:rPr>
              <a:t>February 2021 to actual vaccine uptake in February 2022, stratified by the nonpriority group and the three priority groups.</a:t>
            </a:r>
          </a:p>
          <a:p>
            <a:pPr algn="ctr"/>
            <a:endParaRPr lang="en-US" altLang="ja-JP" sz="2400" dirty="0">
              <a:latin typeface="Cambria" panose="02040503050406030204" pitchFamily="18" charset="0"/>
              <a:ea typeface="Cambria" panose="02040503050406030204" pitchFamily="18" charset="0"/>
            </a:endParaRPr>
          </a:p>
          <a:p>
            <a:pPr algn="ctr"/>
            <a:r>
              <a:rPr lang="en-US" altLang="ja-JP" dirty="0" err="1">
                <a:latin typeface="Cambria" panose="02040503050406030204" pitchFamily="18" charset="0"/>
                <a:ea typeface="Cambria" panose="02040503050406030204" pitchFamily="18" charset="0"/>
              </a:rPr>
              <a:t>ChartExpo</a:t>
            </a:r>
            <a:r>
              <a:rPr lang="en-US" altLang="ja-JP" dirty="0">
                <a:latin typeface="Cambria" panose="02040503050406030204" pitchFamily="18" charset="0"/>
                <a:ea typeface="Cambria" panose="02040503050406030204" pitchFamily="18" charset="0"/>
              </a:rPr>
              <a:t>™ was used to illustrate the </a:t>
            </a:r>
            <a:r>
              <a:rPr lang="en-US" altLang="ja-JP" dirty="0" err="1">
                <a:latin typeface="Cambria" panose="02040503050406030204" pitchFamily="18" charset="0"/>
                <a:ea typeface="Cambria" panose="02040503050406030204" pitchFamily="18" charset="0"/>
              </a:rPr>
              <a:t>Sunkey</a:t>
            </a:r>
            <a:r>
              <a:rPr lang="en-US" altLang="ja-JP" dirty="0">
                <a:latin typeface="Cambria" panose="02040503050406030204" pitchFamily="18" charset="0"/>
                <a:ea typeface="Cambria" panose="02040503050406030204" pitchFamily="18" charset="0"/>
              </a:rPr>
              <a:t> diagram. </a:t>
            </a:r>
          </a:p>
        </p:txBody>
      </p:sp>
    </p:spTree>
    <p:extLst>
      <p:ext uri="{BB962C8B-B14F-4D97-AF65-F5344CB8AC3E}">
        <p14:creationId xmlns:p14="http://schemas.microsoft.com/office/powerpoint/2010/main" val="9412832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BD213602-870D-52AF-DC8C-E6ACE7E14A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523" y="486983"/>
            <a:ext cx="9044940" cy="5569388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B123336-79F2-44C7-B4A0-09A3580B420A}"/>
              </a:ext>
            </a:extLst>
          </p:cNvPr>
          <p:cNvSpPr txBox="1"/>
          <p:nvPr/>
        </p:nvSpPr>
        <p:spPr>
          <a:xfrm>
            <a:off x="651513" y="1211441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13.1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78E1BD9A-BADE-44B1-8908-A4129548C5F4}"/>
              </a:ext>
            </a:extLst>
          </p:cNvPr>
          <p:cNvSpPr txBox="1"/>
          <p:nvPr/>
        </p:nvSpPr>
        <p:spPr>
          <a:xfrm>
            <a:off x="329523" y="5685660"/>
            <a:ext cx="24880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1, February 2021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71FA91E-F683-4216-B947-491C7E800FD1}"/>
              </a:ext>
            </a:extLst>
          </p:cNvPr>
          <p:cNvSpPr txBox="1"/>
          <p:nvPr/>
        </p:nvSpPr>
        <p:spPr>
          <a:xfrm>
            <a:off x="4325789" y="5685660"/>
            <a:ext cx="32136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2, September-October 2021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C3EE7E39-E6D0-422C-A4F0-7A6DCDC9A2C6}"/>
              </a:ext>
            </a:extLst>
          </p:cNvPr>
          <p:cNvSpPr txBox="1"/>
          <p:nvPr/>
        </p:nvSpPr>
        <p:spPr>
          <a:xfrm>
            <a:off x="8343249" y="5685660"/>
            <a:ext cx="24085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3, February 2022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099AD6A-06FA-4CAF-A5B5-7ADB2054EB58}"/>
              </a:ext>
            </a:extLst>
          </p:cNvPr>
          <p:cNvSpPr txBox="1"/>
          <p:nvPr/>
        </p:nvSpPr>
        <p:spPr>
          <a:xfrm>
            <a:off x="651512" y="2858035"/>
            <a:ext cx="263133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58.9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66E2AD1-5B15-41E8-9E8A-126B0F297F59}"/>
              </a:ext>
            </a:extLst>
          </p:cNvPr>
          <p:cNvSpPr txBox="1"/>
          <p:nvPr/>
        </p:nvSpPr>
        <p:spPr>
          <a:xfrm>
            <a:off x="651513" y="4896655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Intended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28.0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1F645BF-5904-4442-B80E-18C36051270B}"/>
              </a:ext>
            </a:extLst>
          </p:cNvPr>
          <p:cNvSpPr txBox="1"/>
          <p:nvPr/>
        </p:nvSpPr>
        <p:spPr>
          <a:xfrm>
            <a:off x="4639314" y="852810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7.7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BE5ED7E-DAC7-4211-96B9-52E3160497CB}"/>
              </a:ext>
            </a:extLst>
          </p:cNvPr>
          <p:cNvSpPr txBox="1"/>
          <p:nvPr/>
        </p:nvSpPr>
        <p:spPr>
          <a:xfrm>
            <a:off x="4639314" y="1314051"/>
            <a:ext cx="29000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8.3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9A7D82E-3B8F-47C0-8F7E-911A5D1CBF91}"/>
              </a:ext>
            </a:extLst>
          </p:cNvPr>
          <p:cNvSpPr txBox="1"/>
          <p:nvPr/>
        </p:nvSpPr>
        <p:spPr>
          <a:xfrm>
            <a:off x="4639314" y="1771192"/>
            <a:ext cx="3048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served/intended, 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6.1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551293D-704C-4FC6-891B-B76DF7255A57}"/>
              </a:ext>
            </a:extLst>
          </p:cNvPr>
          <p:cNvSpPr txBox="1"/>
          <p:nvPr/>
        </p:nvSpPr>
        <p:spPr>
          <a:xfrm>
            <a:off x="4639314" y="2271033"/>
            <a:ext cx="35752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first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12.8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EF36411A-546A-4CBC-99BD-1830AF854AC1}"/>
              </a:ext>
            </a:extLst>
          </p:cNvPr>
          <p:cNvSpPr txBox="1"/>
          <p:nvPr/>
        </p:nvSpPr>
        <p:spPr>
          <a:xfrm>
            <a:off x="4639315" y="4098160"/>
            <a:ext cx="38750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second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65.1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090B15E-0EC6-4E01-9270-BB44FD15C206}"/>
              </a:ext>
            </a:extLst>
          </p:cNvPr>
          <p:cNvSpPr txBox="1"/>
          <p:nvPr/>
        </p:nvSpPr>
        <p:spPr>
          <a:xfrm>
            <a:off x="8644051" y="775826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8.5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144F364-F057-412E-BD4A-F5543074C3D2}"/>
              </a:ext>
            </a:extLst>
          </p:cNvPr>
          <p:cNvSpPr txBox="1"/>
          <p:nvPr/>
        </p:nvSpPr>
        <p:spPr>
          <a:xfrm>
            <a:off x="8644051" y="1121652"/>
            <a:ext cx="243247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4.8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D5AF0260-B6DF-4B71-8A7E-C03229E08CF5}"/>
              </a:ext>
            </a:extLst>
          </p:cNvPr>
          <p:cNvSpPr txBox="1"/>
          <p:nvPr/>
        </p:nvSpPr>
        <p:spPr>
          <a:xfrm>
            <a:off x="8644051" y="1341063"/>
            <a:ext cx="3048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served/intended, 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0.2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E3010E5-2ECF-4358-A8B6-9EBAEF793D18}"/>
              </a:ext>
            </a:extLst>
          </p:cNvPr>
          <p:cNvSpPr txBox="1"/>
          <p:nvPr/>
        </p:nvSpPr>
        <p:spPr>
          <a:xfrm>
            <a:off x="8644050" y="1560475"/>
            <a:ext cx="35479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first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0.6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3E3891C-184E-447F-9C05-0750C3CC9867}"/>
              </a:ext>
            </a:extLst>
          </p:cNvPr>
          <p:cNvSpPr txBox="1"/>
          <p:nvPr/>
        </p:nvSpPr>
        <p:spPr>
          <a:xfrm>
            <a:off x="8644051" y="3451402"/>
            <a:ext cx="367786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second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82.7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B859534-3963-4D41-ACB2-2C93051A346B}"/>
              </a:ext>
            </a:extLst>
          </p:cNvPr>
          <p:cNvSpPr txBox="1"/>
          <p:nvPr/>
        </p:nvSpPr>
        <p:spPr>
          <a:xfrm>
            <a:off x="8644050" y="5232507"/>
            <a:ext cx="35479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third dose, 3.2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207736E-D010-807D-ECED-2D871B0A26F3}"/>
              </a:ext>
            </a:extLst>
          </p:cNvPr>
          <p:cNvSpPr txBox="1"/>
          <p:nvPr/>
        </p:nvSpPr>
        <p:spPr>
          <a:xfrm>
            <a:off x="156085" y="6263984"/>
            <a:ext cx="11879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Figure S1. Nonpriority group (n=7017)</a:t>
            </a:r>
          </a:p>
        </p:txBody>
      </p:sp>
    </p:spTree>
    <p:extLst>
      <p:ext uri="{BB962C8B-B14F-4D97-AF65-F5344CB8AC3E}">
        <p14:creationId xmlns:p14="http://schemas.microsoft.com/office/powerpoint/2010/main" val="33793034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D6E0A538-D486-2EB5-F526-6A3DFD4D13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523" y="478890"/>
            <a:ext cx="9044940" cy="557696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F4E497B-5795-4782-8E33-0DF37026F4A0}"/>
              </a:ext>
            </a:extLst>
          </p:cNvPr>
          <p:cNvSpPr txBox="1"/>
          <p:nvPr/>
        </p:nvSpPr>
        <p:spPr>
          <a:xfrm>
            <a:off x="329523" y="5685921"/>
            <a:ext cx="2874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1, February 2021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768F80A-B5FA-4F67-8ACA-4ED0B8C1B8C6}"/>
              </a:ext>
            </a:extLst>
          </p:cNvPr>
          <p:cNvSpPr txBox="1"/>
          <p:nvPr/>
        </p:nvSpPr>
        <p:spPr>
          <a:xfrm>
            <a:off x="638816" y="1107646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</a:t>
            </a:r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8.9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2B09E3-0078-479F-87A3-E81C3800DF2B}"/>
              </a:ext>
            </a:extLst>
          </p:cNvPr>
          <p:cNvSpPr txBox="1"/>
          <p:nvPr/>
        </p:nvSpPr>
        <p:spPr>
          <a:xfrm>
            <a:off x="638815" y="2461835"/>
            <a:ext cx="25690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50.0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ECABF27A-8FB3-451B-8373-D5FE3B808474}"/>
              </a:ext>
            </a:extLst>
          </p:cNvPr>
          <p:cNvSpPr txBox="1"/>
          <p:nvPr/>
        </p:nvSpPr>
        <p:spPr>
          <a:xfrm>
            <a:off x="638816" y="4554659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Intended, 41.2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183EC93-3C60-404A-99B3-792CBE4B9D94}"/>
              </a:ext>
            </a:extLst>
          </p:cNvPr>
          <p:cNvSpPr txBox="1"/>
          <p:nvPr/>
        </p:nvSpPr>
        <p:spPr>
          <a:xfrm>
            <a:off x="4641267" y="763550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</a:t>
            </a:r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5.0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45270DD-6291-4820-BBC0-7238BC2E7153}"/>
              </a:ext>
            </a:extLst>
          </p:cNvPr>
          <p:cNvSpPr txBox="1"/>
          <p:nvPr/>
        </p:nvSpPr>
        <p:spPr>
          <a:xfrm>
            <a:off x="4641269" y="1133480"/>
            <a:ext cx="25499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</a:t>
            </a:r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5.8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9C0EAC4-9C70-464C-AF9B-6A32CC4DC4E9}"/>
              </a:ext>
            </a:extLst>
          </p:cNvPr>
          <p:cNvSpPr txBox="1"/>
          <p:nvPr/>
        </p:nvSpPr>
        <p:spPr>
          <a:xfrm>
            <a:off x="4641269" y="1425801"/>
            <a:ext cx="30936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served/intended, 3.5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2EA41D1-047A-4CC2-8516-FBF5BF78FE65}"/>
              </a:ext>
            </a:extLst>
          </p:cNvPr>
          <p:cNvSpPr txBox="1"/>
          <p:nvPr/>
        </p:nvSpPr>
        <p:spPr>
          <a:xfrm>
            <a:off x="4641267" y="1756628"/>
            <a:ext cx="35433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first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</a:t>
            </a:r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7.2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7A577C7-DC36-4A7B-9D37-96FBD3A834A5}"/>
              </a:ext>
            </a:extLst>
          </p:cNvPr>
          <p:cNvSpPr txBox="1"/>
          <p:nvPr/>
        </p:nvSpPr>
        <p:spPr>
          <a:xfrm>
            <a:off x="4641268" y="3671120"/>
            <a:ext cx="37019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second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</a:t>
            </a:r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78.5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326213F-BA49-4DAA-B13B-15F81DA27090}"/>
              </a:ext>
            </a:extLst>
          </p:cNvPr>
          <p:cNvSpPr txBox="1"/>
          <p:nvPr/>
        </p:nvSpPr>
        <p:spPr>
          <a:xfrm>
            <a:off x="8660915" y="695779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</a:t>
            </a:r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6.3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BF123E3-C2A6-4693-9AF0-5F00C43CE007}"/>
              </a:ext>
            </a:extLst>
          </p:cNvPr>
          <p:cNvSpPr txBox="1"/>
          <p:nvPr/>
        </p:nvSpPr>
        <p:spPr>
          <a:xfrm>
            <a:off x="8660915" y="974399"/>
            <a:ext cx="28420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</a:t>
            </a:r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2.5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F894098-0A9D-4E3A-99B9-19A7458572CA}"/>
              </a:ext>
            </a:extLst>
          </p:cNvPr>
          <p:cNvSpPr txBox="1"/>
          <p:nvPr/>
        </p:nvSpPr>
        <p:spPr>
          <a:xfrm>
            <a:off x="8660914" y="1197686"/>
            <a:ext cx="3053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served/intended, 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0.2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18480DD-09C7-4F6A-8DD1-B8B142047A06}"/>
              </a:ext>
            </a:extLst>
          </p:cNvPr>
          <p:cNvSpPr txBox="1"/>
          <p:nvPr/>
        </p:nvSpPr>
        <p:spPr>
          <a:xfrm>
            <a:off x="8660914" y="1425801"/>
            <a:ext cx="37019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first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0.4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FDF8186-3C94-45D9-A134-5C69850FBF3E}"/>
              </a:ext>
            </a:extLst>
          </p:cNvPr>
          <p:cNvSpPr txBox="1"/>
          <p:nvPr/>
        </p:nvSpPr>
        <p:spPr>
          <a:xfrm>
            <a:off x="8660913" y="3195217"/>
            <a:ext cx="37019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second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86.2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3ACC2DB-0F84-4825-9E2E-FA8968DB01F7}"/>
              </a:ext>
            </a:extLst>
          </p:cNvPr>
          <p:cNvSpPr txBox="1"/>
          <p:nvPr/>
        </p:nvSpPr>
        <p:spPr>
          <a:xfrm>
            <a:off x="8660914" y="5239945"/>
            <a:ext cx="35310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third dose, 4.3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5C992322-05F1-4C91-8D1B-B647A522C476}"/>
              </a:ext>
            </a:extLst>
          </p:cNvPr>
          <p:cNvSpPr txBox="1"/>
          <p:nvPr/>
        </p:nvSpPr>
        <p:spPr>
          <a:xfrm>
            <a:off x="4325789" y="5685921"/>
            <a:ext cx="37019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2, September-October 2021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8FD67140-9F7E-4801-ADD2-8E7DEEDC171F}"/>
              </a:ext>
            </a:extLst>
          </p:cNvPr>
          <p:cNvSpPr txBox="1"/>
          <p:nvPr/>
        </p:nvSpPr>
        <p:spPr>
          <a:xfrm>
            <a:off x="8343249" y="5685921"/>
            <a:ext cx="24448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3, February 2022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55D9CED-7420-36B2-F101-5D9C42AF4023}"/>
              </a:ext>
            </a:extLst>
          </p:cNvPr>
          <p:cNvSpPr txBox="1"/>
          <p:nvPr/>
        </p:nvSpPr>
        <p:spPr>
          <a:xfrm>
            <a:off x="156085" y="6263984"/>
            <a:ext cx="11879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Figure S2. Priority group of 18-64 years with pre-existing conditions, non-health</a:t>
            </a:r>
            <a:r>
              <a:rPr lang="ja-JP" altLang="en-US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</a:t>
            </a:r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care worker (n=1659)</a:t>
            </a:r>
          </a:p>
        </p:txBody>
      </p:sp>
    </p:spTree>
    <p:extLst>
      <p:ext uri="{BB962C8B-B14F-4D97-AF65-F5344CB8AC3E}">
        <p14:creationId xmlns:p14="http://schemas.microsoft.com/office/powerpoint/2010/main" val="2643379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ロゴ が含まれている画像&#10;&#10;自動的に生成された説明">
            <a:extLst>
              <a:ext uri="{FF2B5EF4-FFF2-40B4-BE49-F238E27FC236}">
                <a16:creationId xmlns:a16="http://schemas.microsoft.com/office/drawing/2014/main" id="{5364A49A-7D96-8E9A-0459-24C56FA28A2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522" y="535535"/>
            <a:ext cx="9029700" cy="5333956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C3C5FED-A67F-48FF-B25A-D33698EC65B6}"/>
              </a:ext>
            </a:extLst>
          </p:cNvPr>
          <p:cNvSpPr txBox="1"/>
          <p:nvPr/>
        </p:nvSpPr>
        <p:spPr>
          <a:xfrm>
            <a:off x="329522" y="5715603"/>
            <a:ext cx="30060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1, February 2021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FD5B880A-7DD3-403B-829A-FEA5CDC4A58D}"/>
              </a:ext>
            </a:extLst>
          </p:cNvPr>
          <p:cNvSpPr txBox="1"/>
          <p:nvPr/>
        </p:nvSpPr>
        <p:spPr>
          <a:xfrm>
            <a:off x="638816" y="998004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6.8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EE70EF8-E065-45CD-A32E-F66C0E2B0FEE}"/>
              </a:ext>
            </a:extLst>
          </p:cNvPr>
          <p:cNvSpPr txBox="1"/>
          <p:nvPr/>
        </p:nvSpPr>
        <p:spPr>
          <a:xfrm>
            <a:off x="638815" y="2083436"/>
            <a:ext cx="27939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40.6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8B747C9-F3E2-4E98-84D2-1E7CAA7C50B7}"/>
              </a:ext>
            </a:extLst>
          </p:cNvPr>
          <p:cNvSpPr txBox="1"/>
          <p:nvPr/>
        </p:nvSpPr>
        <p:spPr>
          <a:xfrm>
            <a:off x="638816" y="4373902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Intended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52.6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185BC77-0B54-49B2-8E0B-38888ACC29E0}"/>
              </a:ext>
            </a:extLst>
          </p:cNvPr>
          <p:cNvSpPr txBox="1"/>
          <p:nvPr/>
        </p:nvSpPr>
        <p:spPr>
          <a:xfrm>
            <a:off x="4632741" y="698781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3.0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805A037-5D98-4334-9BF8-DFA8E3510A6E}"/>
              </a:ext>
            </a:extLst>
          </p:cNvPr>
          <p:cNvSpPr txBox="1"/>
          <p:nvPr/>
        </p:nvSpPr>
        <p:spPr>
          <a:xfrm>
            <a:off x="4632740" y="896734"/>
            <a:ext cx="26224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2.0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CA0794E-E5B8-4004-8ABE-59D6C81EFA40}"/>
              </a:ext>
            </a:extLst>
          </p:cNvPr>
          <p:cNvSpPr txBox="1"/>
          <p:nvPr/>
        </p:nvSpPr>
        <p:spPr>
          <a:xfrm>
            <a:off x="4632740" y="1094687"/>
            <a:ext cx="27724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served/intended, 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0.4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1FFF7C0-4FDB-4E33-A611-E4E4B5D8E3F3}"/>
              </a:ext>
            </a:extLst>
          </p:cNvPr>
          <p:cNvSpPr txBox="1"/>
          <p:nvPr/>
        </p:nvSpPr>
        <p:spPr>
          <a:xfrm>
            <a:off x="4632739" y="1292640"/>
            <a:ext cx="357248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first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0.8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DECE0D22-400A-4B89-B6E6-17B5F50883C3}"/>
              </a:ext>
            </a:extLst>
          </p:cNvPr>
          <p:cNvSpPr txBox="1"/>
          <p:nvPr/>
        </p:nvSpPr>
        <p:spPr>
          <a:xfrm>
            <a:off x="4632740" y="3418788"/>
            <a:ext cx="38013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second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93.8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5B2CC409-5972-477E-B83B-7F4D5428217B}"/>
              </a:ext>
            </a:extLst>
          </p:cNvPr>
          <p:cNvSpPr txBox="1"/>
          <p:nvPr/>
        </p:nvSpPr>
        <p:spPr>
          <a:xfrm>
            <a:off x="8650200" y="676787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</a:t>
            </a:r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3.3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37C1369-028F-4F93-BD3E-AC6EDEB86D6E}"/>
              </a:ext>
            </a:extLst>
          </p:cNvPr>
          <p:cNvSpPr txBox="1"/>
          <p:nvPr/>
        </p:nvSpPr>
        <p:spPr>
          <a:xfrm>
            <a:off x="8650200" y="871985"/>
            <a:ext cx="28678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1.2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2BC5BCCB-9FFA-4719-B33C-AF6DB724EE30}"/>
              </a:ext>
            </a:extLst>
          </p:cNvPr>
          <p:cNvSpPr txBox="1"/>
          <p:nvPr/>
        </p:nvSpPr>
        <p:spPr>
          <a:xfrm>
            <a:off x="8650198" y="1067184"/>
            <a:ext cx="35418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first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0.1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91D190B-ED93-4A40-A765-F313BAEB9C8A}"/>
              </a:ext>
            </a:extLst>
          </p:cNvPr>
          <p:cNvSpPr txBox="1"/>
          <p:nvPr/>
        </p:nvSpPr>
        <p:spPr>
          <a:xfrm>
            <a:off x="8650199" y="2725496"/>
            <a:ext cx="36717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second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71.8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EA7CA49E-DE29-4E55-BAAD-B973462540EA}"/>
              </a:ext>
            </a:extLst>
          </p:cNvPr>
          <p:cNvSpPr txBox="1"/>
          <p:nvPr/>
        </p:nvSpPr>
        <p:spPr>
          <a:xfrm>
            <a:off x="8650198" y="5010368"/>
            <a:ext cx="36717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third dose, 23.6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842D338-7685-409E-AD23-09C24F9B7DA2}"/>
              </a:ext>
            </a:extLst>
          </p:cNvPr>
          <p:cNvSpPr txBox="1"/>
          <p:nvPr/>
        </p:nvSpPr>
        <p:spPr>
          <a:xfrm>
            <a:off x="4325789" y="5715603"/>
            <a:ext cx="504437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2, September-October 2021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59A862E-58DB-4F58-8873-578F8C44B527}"/>
              </a:ext>
            </a:extLst>
          </p:cNvPr>
          <p:cNvSpPr txBox="1"/>
          <p:nvPr/>
        </p:nvSpPr>
        <p:spPr>
          <a:xfrm>
            <a:off x="8343248" y="5715603"/>
            <a:ext cx="300605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3, February 2022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2D44662-ACC7-C6FE-5610-89C5E1E32C0B}"/>
              </a:ext>
            </a:extLst>
          </p:cNvPr>
          <p:cNvSpPr txBox="1"/>
          <p:nvPr/>
        </p:nvSpPr>
        <p:spPr>
          <a:xfrm>
            <a:off x="156085" y="6263984"/>
            <a:ext cx="11879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Figure S3. Priority group of </a:t>
            </a:r>
            <a:r>
              <a:rPr lang="en-US" altLang="ja-JP" sz="1800" dirty="0">
                <a:effectLst/>
                <a:latin typeface="Cambria" panose="02040503050406030204" pitchFamily="18" charset="0"/>
                <a:ea typeface="Cambria" panose="02040503050406030204" pitchFamily="18" charset="0"/>
              </a:rPr>
              <a:t>≥</a:t>
            </a:r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65 years, non-health care worker (n=4048)</a:t>
            </a:r>
          </a:p>
        </p:txBody>
      </p:sp>
    </p:spTree>
    <p:extLst>
      <p:ext uri="{BB962C8B-B14F-4D97-AF65-F5344CB8AC3E}">
        <p14:creationId xmlns:p14="http://schemas.microsoft.com/office/powerpoint/2010/main" val="18594556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D9CBEC0E-1621-5377-3583-5B6DF6F0643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523" y="556730"/>
            <a:ext cx="9054207" cy="5521255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6846982-AE53-460E-BBDC-B0413D153748}"/>
              </a:ext>
            </a:extLst>
          </p:cNvPr>
          <p:cNvSpPr txBox="1"/>
          <p:nvPr/>
        </p:nvSpPr>
        <p:spPr>
          <a:xfrm>
            <a:off x="329522" y="5737469"/>
            <a:ext cx="31543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1, February 2021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E57B1ED-8778-4398-AEB0-71D6F18F7093}"/>
              </a:ext>
            </a:extLst>
          </p:cNvPr>
          <p:cNvSpPr txBox="1"/>
          <p:nvPr/>
        </p:nvSpPr>
        <p:spPr>
          <a:xfrm>
            <a:off x="638816" y="1230491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11.8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0734D52-DF77-4DC6-AC38-42BDD01AD792}"/>
              </a:ext>
            </a:extLst>
          </p:cNvPr>
          <p:cNvSpPr txBox="1"/>
          <p:nvPr/>
        </p:nvSpPr>
        <p:spPr>
          <a:xfrm>
            <a:off x="638815" y="2451179"/>
            <a:ext cx="259906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39.7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A2CFDD9-FBC1-4FD7-9F48-459EA33F26D3}"/>
              </a:ext>
            </a:extLst>
          </p:cNvPr>
          <p:cNvSpPr txBox="1"/>
          <p:nvPr/>
        </p:nvSpPr>
        <p:spPr>
          <a:xfrm>
            <a:off x="638816" y="4519791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Intended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48.5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DC3AD2C-F13B-4BFF-9A64-1CC7A96F2CD3}"/>
              </a:ext>
            </a:extLst>
          </p:cNvPr>
          <p:cNvSpPr txBox="1"/>
          <p:nvPr/>
        </p:nvSpPr>
        <p:spPr>
          <a:xfrm>
            <a:off x="4664716" y="902354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6.3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2A48398-393F-4BBB-959A-9851B737F502}"/>
              </a:ext>
            </a:extLst>
          </p:cNvPr>
          <p:cNvSpPr txBox="1"/>
          <p:nvPr/>
        </p:nvSpPr>
        <p:spPr>
          <a:xfrm>
            <a:off x="4664715" y="1229723"/>
            <a:ext cx="27218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4.3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AA72218-E19B-4B50-9775-3E9D3A510709}"/>
              </a:ext>
            </a:extLst>
          </p:cNvPr>
          <p:cNvSpPr txBox="1"/>
          <p:nvPr/>
        </p:nvSpPr>
        <p:spPr>
          <a:xfrm>
            <a:off x="4664716" y="1533755"/>
            <a:ext cx="28784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served/intended, 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2.6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0FE3D3D2-E932-455C-B364-463CBB8206FC}"/>
              </a:ext>
            </a:extLst>
          </p:cNvPr>
          <p:cNvSpPr txBox="1"/>
          <p:nvPr/>
        </p:nvSpPr>
        <p:spPr>
          <a:xfrm>
            <a:off x="4664714" y="1837788"/>
            <a:ext cx="40872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first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6.1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CE6FC63-B03A-4302-BF37-F839F060DA2B}"/>
              </a:ext>
            </a:extLst>
          </p:cNvPr>
          <p:cNvSpPr txBox="1"/>
          <p:nvPr/>
        </p:nvSpPr>
        <p:spPr>
          <a:xfrm>
            <a:off x="4664715" y="3784679"/>
            <a:ext cx="408727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second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80.6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D14EA52-0069-4E9C-8E32-07C25E411859}"/>
              </a:ext>
            </a:extLst>
          </p:cNvPr>
          <p:cNvSpPr txBox="1"/>
          <p:nvPr/>
        </p:nvSpPr>
        <p:spPr>
          <a:xfrm>
            <a:off x="8677917" y="676787"/>
            <a:ext cx="18350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fused, 4.7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812CB30-7703-4FD6-BD49-590DC9D1E079}"/>
              </a:ext>
            </a:extLst>
          </p:cNvPr>
          <p:cNvSpPr txBox="1"/>
          <p:nvPr/>
        </p:nvSpPr>
        <p:spPr>
          <a:xfrm>
            <a:off x="8677917" y="884165"/>
            <a:ext cx="24897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Waited and saw, 2.0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5E00FCA-CBD3-40AD-9BA2-75913CEB5187}"/>
              </a:ext>
            </a:extLst>
          </p:cNvPr>
          <p:cNvSpPr txBox="1"/>
          <p:nvPr/>
        </p:nvSpPr>
        <p:spPr>
          <a:xfrm>
            <a:off x="8677916" y="1091543"/>
            <a:ext cx="31602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served/intended, 0.2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CB038BA-21D2-4131-9D68-08CDB78BEC0D}"/>
              </a:ext>
            </a:extLst>
          </p:cNvPr>
          <p:cNvSpPr txBox="1"/>
          <p:nvPr/>
        </p:nvSpPr>
        <p:spPr>
          <a:xfrm>
            <a:off x="8677916" y="1298922"/>
            <a:ext cx="35140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first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0.5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D0A1B99-2653-4D99-8EC2-E5FF342EBE57}"/>
              </a:ext>
            </a:extLst>
          </p:cNvPr>
          <p:cNvSpPr txBox="1"/>
          <p:nvPr/>
        </p:nvSpPr>
        <p:spPr>
          <a:xfrm>
            <a:off x="8677916" y="2568408"/>
            <a:ext cx="41496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second dose,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 </a:t>
            </a:r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54.0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CC0BD37A-9DCA-4124-AE91-CD8750895FDB}"/>
              </a:ext>
            </a:extLst>
          </p:cNvPr>
          <p:cNvSpPr txBox="1"/>
          <p:nvPr/>
        </p:nvSpPr>
        <p:spPr>
          <a:xfrm>
            <a:off x="8677915" y="4731948"/>
            <a:ext cx="400376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Received the third dose, 38.5</a:t>
            </a:r>
            <a:r>
              <a:rPr kumimoji="1"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%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0BFB3384-35D4-4BF6-94FC-0F2DBEFEC99D}"/>
              </a:ext>
            </a:extLst>
          </p:cNvPr>
          <p:cNvSpPr txBox="1"/>
          <p:nvPr/>
        </p:nvSpPr>
        <p:spPr>
          <a:xfrm>
            <a:off x="4325789" y="5737469"/>
            <a:ext cx="31543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2, September-October 2021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A9BDF00C-49EE-44A9-B487-E1511CA4B2D3}"/>
              </a:ext>
            </a:extLst>
          </p:cNvPr>
          <p:cNvSpPr txBox="1"/>
          <p:nvPr/>
        </p:nvSpPr>
        <p:spPr>
          <a:xfrm>
            <a:off x="8343248" y="5737469"/>
            <a:ext cx="315432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T3, February 2022</a:t>
            </a:r>
            <a:endParaRPr kumimoji="1" lang="ja-JP" altLang="en-US" sz="1600" b="1" dirty="0">
              <a:latin typeface="Cambria" panose="02040503050406030204" pitchFamily="18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A906BA2-534C-9ED7-EF43-0ACE57876E19}"/>
              </a:ext>
            </a:extLst>
          </p:cNvPr>
          <p:cNvSpPr txBox="1"/>
          <p:nvPr/>
        </p:nvSpPr>
        <p:spPr>
          <a:xfrm>
            <a:off x="156085" y="6263984"/>
            <a:ext cx="118798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Figure S4. Priority group of health care worker (n=831)</a:t>
            </a:r>
          </a:p>
        </p:txBody>
      </p:sp>
    </p:spTree>
    <p:extLst>
      <p:ext uri="{BB962C8B-B14F-4D97-AF65-F5344CB8AC3E}">
        <p14:creationId xmlns:p14="http://schemas.microsoft.com/office/powerpoint/2010/main" val="3330193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09</TotalTime>
  <Words>511</Words>
  <Application>Microsoft Office PowerPoint</Application>
  <PresentationFormat>ワイド画面</PresentationFormat>
  <Paragraphs>84</Paragraphs>
  <Slides>5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10" baseType="lpstr">
      <vt:lpstr>游ゴシック</vt:lpstr>
      <vt:lpstr>游ゴシック Light</vt:lpstr>
      <vt:lpstr>Arial</vt:lpstr>
      <vt:lpstr>Cambri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髙橋司</dc:creator>
  <cp:lastModifiedBy>大介 堀</cp:lastModifiedBy>
  <cp:revision>55</cp:revision>
  <cp:lastPrinted>2022-04-25T06:11:55Z</cp:lastPrinted>
  <dcterms:created xsi:type="dcterms:W3CDTF">2022-04-18T10:20:13Z</dcterms:created>
  <dcterms:modified xsi:type="dcterms:W3CDTF">2023-06-29T07:06:13Z</dcterms:modified>
</cp:coreProperties>
</file>